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3240" y="-8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10.09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-2233"/>
            <a:ext cx="889248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3. 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mparison of the RNA-</a:t>
            </a:r>
            <a:r>
              <a:rPr kumimoji="0" lang="en-US" altLang="ru-RU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eq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results obtained in the pairwise comparison of STR-V vs. NS-V; STR-S vs. STR-V and STR-A vs. STR-V</a:t>
            </a:r>
            <a:endParaRPr kumimoji="0" lang="ru-RU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5608" y="5027692"/>
            <a:ext cx="9128392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endParaRPr kumimoji="0" lang="ru-RU" altLang="ru-RU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.</a:t>
            </a: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Venn diagrams illustrating the results obtained in the STR-V vs. NS-V; STR-S vs. STR-V and STR-A vs. STR-V pairwise comparisons. The numbers within the intersection of the different sets on the Venn diagram indicate the number of DEGs. The cut-off for gene-expression changes was 1.50. Only those genes with a </a:t>
            </a:r>
            <a:r>
              <a:rPr kumimoji="0" lang="en-US" altLang="ru-RU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adj</a:t>
            </a: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&lt;0.05 were selected for analysis. 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</a:t>
            </a: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Differential expression of genes that overlapped between three pairwise comparisons STR-V vs. NS-V; STR-S vs. STR-V and STR-A vs. STR-V. The top ten genes that exhibited the greatest fold change in expression in STR-V vs. NS-V are shown. The data are presented as the mean ± standard error of the mean. 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.</a:t>
            </a: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Hierarchical cluster analysis of all DEGs in the STR-V vs. NS-V; STR-S vs. STR-V and STR-A vs. STR-V pairwise comparisons. Each column represents a comparison group, and each row represents a DEG. Yellow strips represent high relative expression and blue strips represent low relative expression (n = 3 per group).</a:t>
            </a:r>
            <a:endParaRPr kumimoji="0" lang="en-US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J:\Редактируемые\Для публикаций\0_текущие публикации\стресс_2\статья по стрессу2\в Журналы\2_Hormone and behav\рецензия\figS3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460583"/>
            <a:ext cx="8152735" cy="46246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67048855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18</Words>
  <Application>Microsoft Office PowerPoint</Application>
  <PresentationFormat>Экран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3</cp:revision>
  <dcterms:created xsi:type="dcterms:W3CDTF">2020-12-07T15:39:17Z</dcterms:created>
  <dcterms:modified xsi:type="dcterms:W3CDTF">2021-09-10T17:21:30Z</dcterms:modified>
</cp:coreProperties>
</file>